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8.jpeg" ContentType="image/jpe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2072F-B76F-4B13-8AD1-7CF29A776F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67EB5-D837-4578-B7D3-0616CF9AC2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A667C-9DA9-4E09-9153-0695AFBAC9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25D62-B3E4-4147-AB63-C38E6E9464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ED5A4-3338-463D-87F7-9049098E5D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E148B-AB20-4C91-8B30-CB5B96413B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FF9B9-D19B-4BA4-852A-C27AF4D312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633D8-52AE-4AAB-B79A-CE974FC79B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8012F-D688-4794-B96F-40D24AA161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9FF54-A307-4544-90A3-3A8D4DEAC9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6982E-F114-424A-BC6B-33E8C5B655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CA6DC-8F46-49BE-9810-D26331B957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45CEFE-200A-4E4E-9046-B3D138B2ADA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 rot="16200000">
            <a:off x="-378000" y="725760"/>
            <a:ext cx="951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F-7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2"/>
          <p:cNvSpPr/>
          <p:nvPr/>
        </p:nvSpPr>
        <p:spPr>
          <a:xfrm rot="16200000">
            <a:off x="-577080" y="2026080"/>
            <a:ext cx="1289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DA-MB-23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457200" y="119160"/>
            <a:ext cx="1371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-cadher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1982880" y="119160"/>
            <a:ext cx="898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caten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3216240" y="119160"/>
            <a:ext cx="1203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bronec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3"/>
          <p:cNvSpPr/>
          <p:nvPr/>
        </p:nvSpPr>
        <p:spPr>
          <a:xfrm>
            <a:off x="4952880" y="119160"/>
            <a:ext cx="838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r2/neu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2" descr="C:\Users\Carolyn\Desktop\Staining\IHC loose ends 092810\MDA-MB-231 Her 2 20x 1.jpg"/>
          <p:cNvPicPr/>
          <p:nvPr/>
        </p:nvPicPr>
        <p:blipFill>
          <a:blip r:embed="rId1">
            <a:lum contrast="10000"/>
          </a:blip>
          <a:srcRect l="9086" t="16708" r="14560" b="0"/>
          <a:stretch/>
        </p:blipFill>
        <p:spPr>
          <a:xfrm>
            <a:off x="4602240" y="1658880"/>
            <a:ext cx="1417680" cy="11606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3" descr="C:\Users\Carolyn\Desktop\Staining\IHC 82510\MCF-7 Her 2 20x 1.jpg"/>
          <p:cNvPicPr/>
          <p:nvPr/>
        </p:nvPicPr>
        <p:blipFill>
          <a:blip r:embed="rId2">
            <a:lum contrast="10000"/>
          </a:blip>
          <a:srcRect l="16670" t="4434" r="3342" b="3332"/>
          <a:stretch/>
        </p:blipFill>
        <p:spPr>
          <a:xfrm>
            <a:off x="4602240" y="304920"/>
            <a:ext cx="1409760" cy="12189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C:\Users\Carolyn\Desktop\Staining\IHC 070910\MDA-MB-231 fibronectin 20x 6.jpg"/>
          <p:cNvPicPr/>
          <p:nvPr/>
        </p:nvPicPr>
        <p:blipFill>
          <a:blip r:embed="rId3"/>
          <a:srcRect l="6672" t="0" r="10633" b="14444"/>
          <a:stretch/>
        </p:blipFill>
        <p:spPr>
          <a:xfrm>
            <a:off x="3078000" y="1658880"/>
            <a:ext cx="1494000" cy="11606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9" descr="C:\Users\Carolyn\Desktop\Staining\IHC pics for paper 070610\231 E-cad 20x 2.jpg"/>
          <p:cNvPicPr/>
          <p:nvPr/>
        </p:nvPicPr>
        <p:blipFill>
          <a:blip r:embed="rId4"/>
          <a:srcRect l="10006" t="6663" r="10006" b="6663"/>
          <a:stretch/>
        </p:blipFill>
        <p:spPr>
          <a:xfrm>
            <a:off x="193680" y="1658880"/>
            <a:ext cx="1406520" cy="1143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0" descr="C:\Users\Carolyn\Desktop\Staining\IHC pics for paper 070610\MCF-7 E-cad 20x 2.jpg"/>
          <p:cNvPicPr/>
          <p:nvPr/>
        </p:nvPicPr>
        <p:blipFill>
          <a:blip r:embed="rId5"/>
          <a:srcRect l="5831" t="17775" r="23780" b="905"/>
          <a:stretch/>
        </p:blipFill>
        <p:spPr>
          <a:xfrm>
            <a:off x="193680" y="304920"/>
            <a:ext cx="1406520" cy="1218960"/>
          </a:xfrm>
          <a:prstGeom prst="rect">
            <a:avLst/>
          </a:prstGeom>
          <a:ln w="0">
            <a:noFill/>
          </a:ln>
        </p:spPr>
      </p:pic>
      <p:sp>
        <p:nvSpPr>
          <p:cNvPr id="52" name="TextBox 23"/>
          <p:cNvSpPr/>
          <p:nvPr/>
        </p:nvSpPr>
        <p:spPr>
          <a:xfrm>
            <a:off x="152280" y="11916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4"/>
          <p:cNvSpPr/>
          <p:nvPr/>
        </p:nvSpPr>
        <p:spPr>
          <a:xfrm>
            <a:off x="4572000" y="11916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5"/>
          <p:cNvSpPr/>
          <p:nvPr/>
        </p:nvSpPr>
        <p:spPr>
          <a:xfrm>
            <a:off x="2971800" y="11916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6"/>
          <p:cNvSpPr/>
          <p:nvPr/>
        </p:nvSpPr>
        <p:spPr>
          <a:xfrm>
            <a:off x="1585800" y="1473120"/>
            <a:ext cx="38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9"/>
          <p:cNvSpPr/>
          <p:nvPr/>
        </p:nvSpPr>
        <p:spPr>
          <a:xfrm>
            <a:off x="7543800" y="11916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0"/>
          <p:cNvSpPr/>
          <p:nvPr/>
        </p:nvSpPr>
        <p:spPr>
          <a:xfrm>
            <a:off x="3048120" y="147312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1"/>
          <p:cNvSpPr/>
          <p:nvPr/>
        </p:nvSpPr>
        <p:spPr>
          <a:xfrm>
            <a:off x="6019920" y="119160"/>
            <a:ext cx="45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2"/>
          <p:cNvSpPr/>
          <p:nvPr/>
        </p:nvSpPr>
        <p:spPr>
          <a:xfrm>
            <a:off x="4572000" y="1473120"/>
            <a:ext cx="304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33"/>
          <p:cNvSpPr/>
          <p:nvPr/>
        </p:nvSpPr>
        <p:spPr>
          <a:xfrm>
            <a:off x="6172200" y="119160"/>
            <a:ext cx="1295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tokeratin 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3" descr="C:\Users\Carolyn\Desktop\Staining\IHC pics for paper 070610\MCF-7 cyto 8 20x 2.jpg"/>
          <p:cNvPicPr/>
          <p:nvPr/>
        </p:nvPicPr>
        <p:blipFill>
          <a:blip r:embed="rId6"/>
          <a:srcRect l="6676" t="0" r="5829" b="4441"/>
          <a:stretch/>
        </p:blipFill>
        <p:spPr>
          <a:xfrm>
            <a:off x="6056280" y="304920"/>
            <a:ext cx="1487520" cy="12189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" descr="C:\Users\Carolyn\Desktop\Staining\IHC pics for paper 070610\231 cyto 8 20x 3.jpg"/>
          <p:cNvPicPr/>
          <p:nvPr/>
        </p:nvPicPr>
        <p:blipFill>
          <a:blip r:embed="rId7">
            <a:lum contrast="10000"/>
          </a:blip>
          <a:srcRect l="0" t="0" r="2360" b="0"/>
          <a:stretch/>
        </p:blipFill>
        <p:spPr>
          <a:xfrm>
            <a:off x="6056280" y="1658880"/>
            <a:ext cx="1487520" cy="11430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" descr="C:\Users\Carolyn\Desktop\Staining\IHC 101010\231 Ck14 20x 3.jpg"/>
          <p:cNvPicPr/>
          <p:nvPr/>
        </p:nvPicPr>
        <p:blipFill>
          <a:blip r:embed="rId8"/>
          <a:srcRect l="5004" t="0" r="0" b="1764"/>
          <a:stretch/>
        </p:blipFill>
        <p:spPr>
          <a:xfrm>
            <a:off x="7620120" y="1676520"/>
            <a:ext cx="1447560" cy="112212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4" descr="C:\Users\Carolyn\Desktop\Staining\IHC 070910\MCF-7 fibronectin 20x 1.jpg"/>
          <p:cNvPicPr/>
          <p:nvPr/>
        </p:nvPicPr>
        <p:blipFill>
          <a:blip r:embed="rId9"/>
          <a:srcRect l="0" t="13326" r="29181" b="8898"/>
          <a:stretch/>
        </p:blipFill>
        <p:spPr>
          <a:xfrm>
            <a:off x="3078000" y="304920"/>
            <a:ext cx="1494000" cy="1230120"/>
          </a:xfrm>
          <a:prstGeom prst="rect">
            <a:avLst/>
          </a:prstGeom>
          <a:ln w="0">
            <a:noFill/>
          </a:ln>
        </p:spPr>
      </p:pic>
      <p:sp>
        <p:nvSpPr>
          <p:cNvPr id="65" name="TextBox 27"/>
          <p:cNvSpPr/>
          <p:nvPr/>
        </p:nvSpPr>
        <p:spPr>
          <a:xfrm>
            <a:off x="6019920" y="149076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3" descr="C:\Users\Carolyn\Desktop\Staining\IHC 101010\MCF-7 Ck14 20x 1.jpg"/>
          <p:cNvPicPr/>
          <p:nvPr/>
        </p:nvPicPr>
        <p:blipFill>
          <a:blip r:embed="rId10"/>
          <a:srcRect l="0" t="0" r="10944" b="0"/>
          <a:stretch/>
        </p:blipFill>
        <p:spPr>
          <a:xfrm>
            <a:off x="7620120" y="304920"/>
            <a:ext cx="1447560" cy="121896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7" descr="C:\Users\Carolyn\Desktop\Staining\IHC 070210\231 B-catenin 20x 3.jpg"/>
          <p:cNvPicPr/>
          <p:nvPr/>
        </p:nvPicPr>
        <p:blipFill>
          <a:blip r:embed="rId11">
            <a:lum contrast="6000"/>
          </a:blip>
          <a:srcRect l="10836" t="0" r="15472" b="18880"/>
          <a:stretch/>
        </p:blipFill>
        <p:spPr>
          <a:xfrm>
            <a:off x="1647720" y="1658880"/>
            <a:ext cx="1400400" cy="11574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8" descr="C:\Users\Carolyn\Desktop\Staining\IHC 070210\MCF-7 B-catenin 20x 2.jpg"/>
          <p:cNvPicPr/>
          <p:nvPr/>
        </p:nvPicPr>
        <p:blipFill>
          <a:blip r:embed="rId12"/>
          <a:srcRect l="12498" t="0" r="16403" b="16674"/>
          <a:stretch/>
        </p:blipFill>
        <p:spPr>
          <a:xfrm>
            <a:off x="1647720" y="304920"/>
            <a:ext cx="1386000" cy="1218960"/>
          </a:xfrm>
          <a:prstGeom prst="rect">
            <a:avLst/>
          </a:prstGeom>
          <a:ln w="0">
            <a:noFill/>
          </a:ln>
        </p:spPr>
      </p:pic>
      <p:sp>
        <p:nvSpPr>
          <p:cNvPr id="69" name="TextBox 27"/>
          <p:cNvSpPr/>
          <p:nvPr/>
        </p:nvSpPr>
        <p:spPr>
          <a:xfrm>
            <a:off x="76320" y="147312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8"/>
          <p:cNvSpPr/>
          <p:nvPr/>
        </p:nvSpPr>
        <p:spPr>
          <a:xfrm>
            <a:off x="1585800" y="119160"/>
            <a:ext cx="38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7"/>
          <p:cNvSpPr/>
          <p:nvPr/>
        </p:nvSpPr>
        <p:spPr>
          <a:xfrm>
            <a:off x="7543800" y="1490760"/>
            <a:ext cx="380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3"/>
          <p:cNvSpPr/>
          <p:nvPr/>
        </p:nvSpPr>
        <p:spPr>
          <a:xfrm>
            <a:off x="7696080" y="119160"/>
            <a:ext cx="129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tokeratin 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3T19:16:16Z</dcterms:created>
  <dc:creator>Carolyn</dc:creator>
  <dc:description/>
  <dc:language>en-US</dc:language>
  <cp:lastModifiedBy>Carolyn</cp:lastModifiedBy>
  <dcterms:modified xsi:type="dcterms:W3CDTF">2011-11-23T19:35:05Z</dcterms:modified>
  <cp:revision>23</cp:revision>
  <dc:subject/>
  <dc:title>Slide 1</dc:title>
</cp:coreProperties>
</file>